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72" r:id="rId3"/>
    <p:sldId id="271" r:id="rId4"/>
  </p:sldIdLst>
  <p:sldSz cx="9144000" cy="6858000" type="screen4x3"/>
  <p:notesSz cx="6865938" cy="99980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6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1989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2183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0437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2374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4642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9235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9592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8893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3982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7055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altLang="ko-K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5501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15ACA-99A8-47FC-BD7F-FBFC8D6422F6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6A4FB6-B471-4074-8D57-63684E4033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0465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199" y="2103504"/>
            <a:ext cx="3900086" cy="240962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71776" y="2139274"/>
            <a:ext cx="3491314" cy="237385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308971" y="243840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c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920004" y="2438399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c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00285" y="2443126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c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352057" y="2438398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c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23403" y="4328461"/>
            <a:ext cx="1105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itol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570802" y="4364231"/>
            <a:ext cx="1105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a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226941" y="5323726"/>
            <a:ext cx="28190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3590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016157A-DBE3-4008-9AFF-A83D3CB334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1748684"/>
              </p:ext>
            </p:extLst>
          </p:nvPr>
        </p:nvGraphicFramePr>
        <p:xfrm>
          <a:off x="1860482" y="872454"/>
          <a:ext cx="4611071" cy="49744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5" r:id="rId3" imgW="6372000" imgH="6876000" progId="Prism5.Document">
                  <p:embed/>
                </p:oleObj>
              </mc:Choice>
              <mc:Fallback>
                <p:oleObj name="Prism 5" r:id="rId3" imgW="6372000" imgH="687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60482" y="872454"/>
                        <a:ext cx="4611071" cy="49744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3BBB9A5-6EE2-404F-A036-C8F1585CADB1}"/>
              </a:ext>
            </a:extLst>
          </p:cNvPr>
          <p:cNvSpPr txBox="1"/>
          <p:nvPr/>
        </p:nvSpPr>
        <p:spPr>
          <a:xfrm>
            <a:off x="3505200" y="6209637"/>
            <a:ext cx="28190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20890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381910" y="6250733"/>
            <a:ext cx="28190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3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0D074CD-71C9-4076-BD4D-15656EF75F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6311462"/>
              </p:ext>
            </p:extLst>
          </p:nvPr>
        </p:nvGraphicFramePr>
        <p:xfrm>
          <a:off x="1786856" y="816433"/>
          <a:ext cx="4931596" cy="52320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5" r:id="rId3" imgW="6480000" imgH="6876000" progId="Prism5.Document">
                  <p:embed/>
                </p:oleObj>
              </mc:Choice>
              <mc:Fallback>
                <p:oleObj name="Prism 5" r:id="rId3" imgW="6480000" imgH="687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86856" y="816433"/>
                        <a:ext cx="4931596" cy="52320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47199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1</TotalTime>
  <Words>18</Words>
  <Application>Microsoft Office PowerPoint</Application>
  <PresentationFormat>On-screen Show (4:3)</PresentationFormat>
  <Paragraphs>9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Times New Roman</vt:lpstr>
      <vt:lpstr>Office Theme</vt:lpstr>
      <vt:lpstr>Prism 5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lam Md. Tabibul</dc:creator>
  <cp:lastModifiedBy>Islam, Tabibul</cp:lastModifiedBy>
  <cp:revision>30</cp:revision>
  <cp:lastPrinted>2018-11-28T07:40:26Z</cp:lastPrinted>
  <dcterms:created xsi:type="dcterms:W3CDTF">2018-11-14T10:34:48Z</dcterms:created>
  <dcterms:modified xsi:type="dcterms:W3CDTF">2021-01-26T17:56:05Z</dcterms:modified>
</cp:coreProperties>
</file>